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565" r:id="rId2"/>
    <p:sldId id="567" r:id="rId3"/>
  </p:sldIdLst>
  <p:sldSz cx="12192000" cy="6858000"/>
  <p:notesSz cx="6735763" cy="98663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fei Wang" initials="YW" lastIdx="1" clrIdx="0">
    <p:extLst>
      <p:ext uri="{19B8F6BF-5375-455C-9EA6-DF929625EA0E}">
        <p15:presenceInfo xmlns:p15="http://schemas.microsoft.com/office/powerpoint/2012/main" userId="5d421dc98dcc388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04" autoAdjust="0"/>
    <p:restoredTop sz="93617" autoAdjust="0"/>
  </p:normalViewPr>
  <p:slideViewPr>
    <p:cSldViewPr snapToGrid="0">
      <p:cViewPr varScale="1">
        <p:scale>
          <a:sx n="80" d="100"/>
          <a:sy n="80" d="100"/>
        </p:scale>
        <p:origin x="18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&#29579;&#29233;&#20891;%20CgM2\Cg%20CBM%209.13%20&#30343;&#31179;&#20029;&#25972;&#29702;\&#25237;&#31295;&#25991;&#20214;%20CgCBM\old\&#38468;&#20214;2.%20-%2010.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3!$H$1:$H$24</c:f>
              <c:strCache>
                <c:ptCount val="24"/>
                <c:pt idx="0">
                  <c:v>ABRE</c:v>
                </c:pt>
                <c:pt idx="1">
                  <c:v>AuxRR-core</c:v>
                </c:pt>
                <c:pt idx="2">
                  <c:v>CAT-box</c:v>
                </c:pt>
                <c:pt idx="3">
                  <c:v>CGTCA-motif</c:v>
                </c:pt>
                <c:pt idx="4">
                  <c:v>G-box</c:v>
                </c:pt>
                <c:pt idx="5">
                  <c:v>GC-motif</c:v>
                </c:pt>
                <c:pt idx="6">
                  <c:v>GCN4_motif</c:v>
                </c:pt>
                <c:pt idx="7">
                  <c:v>GT1-motif</c:v>
                </c:pt>
                <c:pt idx="8">
                  <c:v>MBS</c:v>
                </c:pt>
                <c:pt idx="9">
                  <c:v>O2-site</c:v>
                </c:pt>
                <c:pt idx="10">
                  <c:v>TC-rich repeats</c:v>
                </c:pt>
                <c:pt idx="11">
                  <c:v>TCT-motif</c:v>
                </c:pt>
                <c:pt idx="12">
                  <c:v>TGACG-motif</c:v>
                </c:pt>
                <c:pt idx="13">
                  <c:v>ARE</c:v>
                </c:pt>
                <c:pt idx="14">
                  <c:v>CCAAT-box</c:v>
                </c:pt>
                <c:pt idx="15">
                  <c:v>GARE-motif</c:v>
                </c:pt>
                <c:pt idx="16">
                  <c:v>LTR</c:v>
                </c:pt>
                <c:pt idx="17">
                  <c:v>P-box</c:v>
                </c:pt>
                <c:pt idx="18">
                  <c:v>Sp1</c:v>
                </c:pt>
                <c:pt idx="19">
                  <c:v>TGA-element</c:v>
                </c:pt>
                <c:pt idx="20">
                  <c:v>GATA-motif</c:v>
                </c:pt>
                <c:pt idx="21">
                  <c:v>TATC-box</c:v>
                </c:pt>
                <c:pt idx="22">
                  <c:v>Box 4</c:v>
                </c:pt>
                <c:pt idx="23">
                  <c:v>TCA-element</c:v>
                </c:pt>
              </c:strCache>
            </c:strRef>
          </c:cat>
          <c:val>
            <c:numRef>
              <c:f>Sheet3!$I$1:$I$24</c:f>
              <c:numCache>
                <c:formatCode>General</c:formatCode>
                <c:ptCount val="24"/>
                <c:pt idx="0">
                  <c:v>289</c:v>
                </c:pt>
                <c:pt idx="1">
                  <c:v>15</c:v>
                </c:pt>
                <c:pt idx="2">
                  <c:v>90</c:v>
                </c:pt>
                <c:pt idx="3">
                  <c:v>350</c:v>
                </c:pt>
                <c:pt idx="4">
                  <c:v>303</c:v>
                </c:pt>
                <c:pt idx="5">
                  <c:v>55</c:v>
                </c:pt>
                <c:pt idx="6">
                  <c:v>11</c:v>
                </c:pt>
                <c:pt idx="7">
                  <c:v>64</c:v>
                </c:pt>
                <c:pt idx="8">
                  <c:v>102</c:v>
                </c:pt>
                <c:pt idx="9">
                  <c:v>53</c:v>
                </c:pt>
                <c:pt idx="10">
                  <c:v>16</c:v>
                </c:pt>
                <c:pt idx="11">
                  <c:v>70</c:v>
                </c:pt>
                <c:pt idx="12">
                  <c:v>335</c:v>
                </c:pt>
                <c:pt idx="13">
                  <c:v>93</c:v>
                </c:pt>
                <c:pt idx="14">
                  <c:v>118</c:v>
                </c:pt>
                <c:pt idx="15">
                  <c:v>32</c:v>
                </c:pt>
                <c:pt idx="16">
                  <c:v>92</c:v>
                </c:pt>
                <c:pt idx="17">
                  <c:v>35</c:v>
                </c:pt>
                <c:pt idx="18">
                  <c:v>92</c:v>
                </c:pt>
                <c:pt idx="19">
                  <c:v>90</c:v>
                </c:pt>
                <c:pt idx="20">
                  <c:v>43</c:v>
                </c:pt>
                <c:pt idx="21">
                  <c:v>18</c:v>
                </c:pt>
                <c:pt idx="22">
                  <c:v>36</c:v>
                </c:pt>
                <c:pt idx="23">
                  <c:v>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FAA-4F96-A1BA-CC2356AA769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62024879"/>
        <c:axId val="1462026799"/>
      </c:barChart>
      <c:catAx>
        <c:axId val="14620248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zh-CN"/>
          </a:p>
        </c:txPr>
        <c:crossAx val="1462026799"/>
        <c:crosses val="autoZero"/>
        <c:auto val="1"/>
        <c:lblAlgn val="ctr"/>
        <c:lblOffset val="100"/>
        <c:noMultiLvlLbl val="0"/>
      </c:catAx>
      <c:valAx>
        <c:axId val="146202679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+mn-cs"/>
                  </a:defRPr>
                </a:pPr>
                <a:r>
                  <a:rPr lang="en-US" altLang="zh-CN" sz="2200" baseline="0">
                    <a:latin typeface="Times New Roman" panose="02020603050405020304" pitchFamily="18" charset="0"/>
                  </a:rPr>
                  <a:t>Numbers of CAREs</a:t>
                </a:r>
                <a:endParaRPr lang="zh-CN" altLang="en-US" sz="2200" baseline="0">
                  <a:latin typeface="Times New Roman" panose="02020603050405020304" pitchFamily="18" charset="0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+mn-cs"/>
              </a:defRPr>
            </a:pPr>
            <a:endParaRPr lang="zh-CN"/>
          </a:p>
        </c:txPr>
        <c:crossAx val="146202487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11935C-5BF3-40EA-8836-363533A29B7B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78ED1B1-2FC7-4389-A91B-E9C2E5CBCF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4989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1902EA-8255-5919-5F12-1BAB43D27EF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DCB5521-22AB-B076-49A3-EE99277574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7075AEA-EE49-47A1-9788-C689D5874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AAF978-4377-9604-8B59-2FFE26FD77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519DE7-E0DE-729A-5B17-7D95565AE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06227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F00216D-2AE3-F658-67F7-9BAAB56986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9E6A615-5327-3C51-5701-37AA7B0E84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0FD60C-AAB8-75C5-97BD-DDB770A0BB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89B7A89-99E2-2B65-A984-EB6E128AE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1E8CE4C-82C1-25C2-A4EC-465C086BEA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6854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ED669D3-26AE-7A8B-0D2E-D0F5304CA7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E07FF1C-841C-4EBF-561E-FEF7D1BC80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FC5003-DCF7-EF06-C1BF-B391C3F310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37996B4-D351-9E14-C7B2-B240EB33DF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77BF0BD-4FCA-FF0B-C02B-A9E7D2B95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297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30CD339-E910-6F5E-C811-1719C1BA34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13BE5A3-1006-246D-CDE4-7BA9C757F55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9B38E1-058A-034D-011F-DA0910512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D41DD87-DF48-2E06-C95F-41878ED53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07A39A-C007-117B-9BBE-3307EDA4A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1557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03C178-9C8F-A246-922A-AF36303426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ED0AD21-5E06-E334-9F50-44BDF5145E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55BA177-B9CB-48B8-8B40-58B848DB99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82FD2AD-4920-8CA8-3187-D872C6D183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2F70017-6A46-5866-E423-D29EB266EF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2254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E974D88-0BF2-FF3B-7E6D-29A21B480B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AD1A06A-A8E2-9A94-6308-1DBEC8950D1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7F6695F-698F-AAF0-4CAA-2D50ED3BB1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71EFC97-BC7A-E5F1-FC52-BCBA4AED0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6EC504F-58AC-F5BB-5BBE-15DE470F0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50BCF69-EDD4-B8C7-2E68-A093C9EE6E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841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255594-EC16-FDF8-453A-7122156915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2D9350D-95FA-5C00-E8C2-0FE4AD423D9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0839424-EC0D-372F-8069-DFB6F6B250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13C9BE6-A344-7904-F97A-643811CCA85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6F4B968-8402-395F-3112-E23DF06526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8BA2A1F8-E408-8B55-3EFD-6DFD8C7C17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346F8D6D-40A1-F910-68F3-41EDEE572C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69A4E286-F072-4C14-F37F-01289651F4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1590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AD72F4-2CFE-33BC-25F0-074B76790C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B1CDA7E-9473-53D3-7299-5D6137F0B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F4C824B-E306-798D-9B55-35437A11F7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47F8DB9-F33D-F88E-C463-D6CD9D9B40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3208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80ABEF0-C457-C5D4-92C9-6BFA504987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358ADBB-7427-B58E-AF25-70E250F80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1E6A55D-7760-4CFB-254C-DB390341F8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4518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9DABF28-0976-ED42-BC8F-46A26E8A3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F9D48E9-E5B4-0616-02FD-FBCD7FF173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5FF40C0-CD52-CF87-7143-0980422D1B4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EC41D5-B041-9C1D-5340-CEAF4E2B2D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FA4280B-62E9-F36D-4A53-5D4604C1BC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130DD40-966C-E300-0D9E-D48820AF46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1804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2DC79C-9FC2-0111-356F-F1D9A5B61B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234B2D3-E5FC-8BA0-F872-2255BFCC2C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B31083C-6FD5-2523-5978-5FA4C2D286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D1EC8B7-1255-0FF1-7E1D-35B9AC5C9F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933F0DC-5EE2-B8FE-F5E9-8EE625854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D0CF573-6B4A-7BCE-D887-D55AD64C06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5750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4A45F46-90F3-2B13-1320-C2ABE14AB9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4214413-5A82-7285-D382-654B2129AC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4EDC4C7-9EF5-5F17-7464-5E61DD5E276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9DAFD-166B-4D60-9948-881B2DB5277E}" type="datetimeFigureOut">
              <a:rPr lang="zh-CN" altLang="en-US" smtClean="0"/>
              <a:t>2025/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EB56E76-4B99-D9CC-3AFE-AC796C3DC3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39CEE1E-83FF-A695-3267-586E23CECC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0449EF-B375-40A8-B0D2-5955B1BC5B1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928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D9CE638-93F3-E71C-B908-48AED24A9DB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1">
            <a:extLst>
              <a:ext uri="{FF2B5EF4-FFF2-40B4-BE49-F238E27FC236}">
                <a16:creationId xmlns:a16="http://schemas.microsoft.com/office/drawing/2014/main" id="{D8BA8336-9218-E2D4-36DB-7D18266C93FB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58" y="154625"/>
            <a:ext cx="2249570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" name="图片 2">
            <a:extLst>
              <a:ext uri="{FF2B5EF4-FFF2-40B4-BE49-F238E27FC236}">
                <a16:creationId xmlns:a16="http://schemas.microsoft.com/office/drawing/2014/main" id="{1D99CCAD-E8B0-ECC2-15AB-377EDCCBB9C8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58" y="1273971"/>
            <a:ext cx="4842192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图片 3">
            <a:extLst>
              <a:ext uri="{FF2B5EF4-FFF2-40B4-BE49-F238E27FC236}">
                <a16:creationId xmlns:a16="http://schemas.microsoft.com/office/drawing/2014/main" id="{9928B9B3-9193-1625-0BC6-15CBC32FFCE5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58" y="2441975"/>
            <a:ext cx="5875902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图片 4">
            <a:extLst>
              <a:ext uri="{FF2B5EF4-FFF2-40B4-BE49-F238E27FC236}">
                <a16:creationId xmlns:a16="http://schemas.microsoft.com/office/drawing/2014/main" id="{C63BD68C-C05A-609D-9D31-AF19629FEBFB}"/>
              </a:ext>
            </a:extLst>
          </p:cNvPr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58" y="3611168"/>
            <a:ext cx="2462080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图片 5">
            <a:extLst>
              <a:ext uri="{FF2B5EF4-FFF2-40B4-BE49-F238E27FC236}">
                <a16:creationId xmlns:a16="http://schemas.microsoft.com/office/drawing/2014/main" id="{E518CA92-8E1A-1F0A-CA8C-67AF1A1213AA}"/>
              </a:ext>
            </a:extLst>
          </p:cNvPr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8958" y="4807746"/>
            <a:ext cx="1085319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图片 6">
            <a:extLst>
              <a:ext uri="{FF2B5EF4-FFF2-40B4-BE49-F238E27FC236}">
                <a16:creationId xmlns:a16="http://schemas.microsoft.com/office/drawing/2014/main" id="{405B25B5-5FD7-342D-9302-88C66D9215F1}"/>
              </a:ext>
            </a:extLst>
          </p:cNvPr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4557" y="166690"/>
            <a:ext cx="2580479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图片 7">
            <a:extLst>
              <a:ext uri="{FF2B5EF4-FFF2-40B4-BE49-F238E27FC236}">
                <a16:creationId xmlns:a16="http://schemas.microsoft.com/office/drawing/2014/main" id="{91A90D02-D9C2-C095-279D-2D5FBA0874C6}"/>
              </a:ext>
            </a:extLst>
          </p:cNvPr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4558" y="1309690"/>
            <a:ext cx="3230152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图片 8">
            <a:extLst>
              <a:ext uri="{FF2B5EF4-FFF2-40B4-BE49-F238E27FC236}">
                <a16:creationId xmlns:a16="http://schemas.microsoft.com/office/drawing/2014/main" id="{2D276212-819B-F775-022B-9F94CD7EE9CC}"/>
              </a:ext>
            </a:extLst>
          </p:cNvPr>
          <p:cNvPicPr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4558" y="2457452"/>
            <a:ext cx="4842192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图片 9">
            <a:extLst>
              <a:ext uri="{FF2B5EF4-FFF2-40B4-BE49-F238E27FC236}">
                <a16:creationId xmlns:a16="http://schemas.microsoft.com/office/drawing/2014/main" id="{2157E694-D6FF-94E1-A145-EEB0CD315117}"/>
              </a:ext>
            </a:extLst>
          </p:cNvPr>
          <p:cNvPicPr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4557" y="3619582"/>
            <a:ext cx="3347033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图片 10">
            <a:extLst>
              <a:ext uri="{FF2B5EF4-FFF2-40B4-BE49-F238E27FC236}">
                <a16:creationId xmlns:a16="http://schemas.microsoft.com/office/drawing/2014/main" id="{645F2CE3-B1DE-11A4-ADA9-B403AA0FD8EF}"/>
              </a:ext>
            </a:extLst>
          </p:cNvPr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54558" y="4846005"/>
            <a:ext cx="4723793" cy="1063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文本框 12">
            <a:extLst>
              <a:ext uri="{FF2B5EF4-FFF2-40B4-BE49-F238E27FC236}">
                <a16:creationId xmlns:a16="http://schemas.microsoft.com/office/drawing/2014/main" id="{3F9643B9-8BF2-5CF7-FA5B-A5DBA8BEEB4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919" y="547199"/>
            <a:ext cx="737145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1</a:t>
            </a:r>
          </a:p>
        </p:txBody>
      </p:sp>
      <p:sp>
        <p:nvSpPr>
          <p:cNvPr id="15" name="文本框 13">
            <a:extLst>
              <a:ext uri="{FF2B5EF4-FFF2-40B4-BE49-F238E27FC236}">
                <a16:creationId xmlns:a16="http://schemas.microsoft.com/office/drawing/2014/main" id="{96DC852F-6E10-24A2-025E-0C39C1D139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920" y="1776682"/>
            <a:ext cx="781956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2</a:t>
            </a:r>
          </a:p>
        </p:txBody>
      </p:sp>
      <p:sp>
        <p:nvSpPr>
          <p:cNvPr id="16" name="文本框 14">
            <a:extLst>
              <a:ext uri="{FF2B5EF4-FFF2-40B4-BE49-F238E27FC236}">
                <a16:creationId xmlns:a16="http://schemas.microsoft.com/office/drawing/2014/main" id="{0278FA55-123F-3744-6AF5-691FB62F657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27520" y="670043"/>
            <a:ext cx="911162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6</a:t>
            </a:r>
          </a:p>
        </p:txBody>
      </p:sp>
      <p:sp>
        <p:nvSpPr>
          <p:cNvPr id="17" name="文本框 15">
            <a:extLst>
              <a:ext uri="{FF2B5EF4-FFF2-40B4-BE49-F238E27FC236}">
                <a16:creationId xmlns:a16="http://schemas.microsoft.com/office/drawing/2014/main" id="{58F5FD3F-C4A8-9C2D-1978-BECEC94B2A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27520" y="1710218"/>
            <a:ext cx="679638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7</a:t>
            </a:r>
          </a:p>
        </p:txBody>
      </p:sp>
      <p:sp>
        <p:nvSpPr>
          <p:cNvPr id="18" name="文本框 30">
            <a:extLst>
              <a:ext uri="{FF2B5EF4-FFF2-40B4-BE49-F238E27FC236}">
                <a16:creationId xmlns:a16="http://schemas.microsoft.com/office/drawing/2014/main" id="{AB4887C8-558B-2906-14F8-02EFD269233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920" y="2837330"/>
            <a:ext cx="714740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3</a:t>
            </a:r>
            <a:endParaRPr lang="zh-CN" altLang="en-US" sz="750">
              <a:latin typeface="Times New Roman" panose="02020603050405020304" pitchFamily="18" charset="0"/>
            </a:endParaRPr>
          </a:p>
        </p:txBody>
      </p:sp>
      <p:sp>
        <p:nvSpPr>
          <p:cNvPr id="19" name="文本框 31">
            <a:extLst>
              <a:ext uri="{FF2B5EF4-FFF2-40B4-BE49-F238E27FC236}">
                <a16:creationId xmlns:a16="http://schemas.microsoft.com/office/drawing/2014/main" id="{2D375CAB-717F-7E5F-5478-A643F658375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919" y="4084686"/>
            <a:ext cx="748349" cy="35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4</a:t>
            </a:r>
            <a:endParaRPr lang="zh-CN" altLang="en-US" sz="750">
              <a:latin typeface="Times New Roman" panose="02020603050405020304" pitchFamily="18" charset="0"/>
            </a:endParaRPr>
          </a:p>
        </p:txBody>
      </p:sp>
      <p:sp>
        <p:nvSpPr>
          <p:cNvPr id="20" name="文本框 32">
            <a:extLst>
              <a:ext uri="{FF2B5EF4-FFF2-40B4-BE49-F238E27FC236}">
                <a16:creationId xmlns:a16="http://schemas.microsoft.com/office/drawing/2014/main" id="{41231587-361E-F839-4C21-685A5B46D7D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21920" y="5326860"/>
            <a:ext cx="781956" cy="4038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US" altLang="zh-CN" sz="750" dirty="0">
                <a:latin typeface="Times New Roman" panose="02020603050405020304" pitchFamily="18" charset="0"/>
              </a:rPr>
              <a:t>Motif 5</a:t>
            </a:r>
            <a:endParaRPr lang="zh-CN" altLang="en-US" sz="750" dirty="0">
              <a:latin typeface="Times New Roman" panose="02020603050405020304" pitchFamily="18" charset="0"/>
            </a:endParaRPr>
          </a:p>
        </p:txBody>
      </p:sp>
      <p:sp>
        <p:nvSpPr>
          <p:cNvPr id="21" name="文本框 35">
            <a:extLst>
              <a:ext uri="{FF2B5EF4-FFF2-40B4-BE49-F238E27FC236}">
                <a16:creationId xmlns:a16="http://schemas.microsoft.com/office/drawing/2014/main" id="{9657B3C2-FE3C-5C33-51AC-1538BB09DCA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32206" y="2973761"/>
            <a:ext cx="673663" cy="359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8</a:t>
            </a:r>
            <a:endParaRPr lang="zh-CN" altLang="en-US" sz="750">
              <a:latin typeface="Times New Roman" panose="02020603050405020304" pitchFamily="18" charset="0"/>
            </a:endParaRPr>
          </a:p>
        </p:txBody>
      </p:sp>
      <p:sp>
        <p:nvSpPr>
          <p:cNvPr id="22" name="文本框 36">
            <a:extLst>
              <a:ext uri="{FF2B5EF4-FFF2-40B4-BE49-F238E27FC236}">
                <a16:creationId xmlns:a16="http://schemas.microsoft.com/office/drawing/2014/main" id="{197FB2E8-0563-3AC3-0A1C-8883DFB6B0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27520" y="3932731"/>
            <a:ext cx="714740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9</a:t>
            </a:r>
            <a:endParaRPr lang="zh-CN" altLang="en-US" sz="750">
              <a:latin typeface="Times New Roman" panose="02020603050405020304" pitchFamily="18" charset="0"/>
            </a:endParaRPr>
          </a:p>
        </p:txBody>
      </p:sp>
      <p:sp>
        <p:nvSpPr>
          <p:cNvPr id="23" name="文本框 37">
            <a:extLst>
              <a:ext uri="{FF2B5EF4-FFF2-40B4-BE49-F238E27FC236}">
                <a16:creationId xmlns:a16="http://schemas.microsoft.com/office/drawing/2014/main" id="{7F05BDDB-971A-F5CB-7923-E6045C04450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827520" y="5281741"/>
            <a:ext cx="901453" cy="2077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r>
              <a:rPr lang="en-US" altLang="zh-CN" sz="750">
                <a:latin typeface="Times New Roman" panose="02020603050405020304" pitchFamily="18" charset="0"/>
              </a:rPr>
              <a:t>Motif 10</a:t>
            </a:r>
            <a:endParaRPr lang="zh-CN" altLang="en-US" sz="750">
              <a:latin typeface="Times New Roman" panose="02020603050405020304" pitchFamily="18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4CCC4D75-1B07-3784-2276-9CA05B96A854}"/>
              </a:ext>
            </a:extLst>
          </p:cNvPr>
          <p:cNvSpPr txBox="1"/>
          <p:nvPr/>
        </p:nvSpPr>
        <p:spPr>
          <a:xfrm>
            <a:off x="132080" y="6252081"/>
            <a:ext cx="118465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600" b="1" kern="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zh-CN" sz="16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6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 logo conserved motif of CgCBM proteins.</a:t>
            </a:r>
            <a:endParaRPr lang="zh-CN" altLang="zh-CN" sz="1600" kern="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70891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F18B419-C138-1DAA-981A-5235F7B34C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6">
            <a:extLst>
              <a:ext uri="{FF2B5EF4-FFF2-40B4-BE49-F238E27FC236}">
                <a16:creationId xmlns:a16="http://schemas.microsoft.com/office/drawing/2014/main" id="{D5FD0FDC-70BF-7270-B4ED-1F34077CC267}"/>
              </a:ext>
            </a:extLst>
          </p:cNvPr>
          <p:cNvSpPr txBox="1"/>
          <p:nvPr/>
        </p:nvSpPr>
        <p:spPr>
          <a:xfrm>
            <a:off x="1532173" y="6215479"/>
            <a:ext cx="8346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PalatinoLinotype-Roman"/>
              </a:rPr>
              <a:t>Figure S2</a:t>
            </a:r>
            <a:r>
              <a:rPr lang="en-US" altLang="zh-CN" dirty="0">
                <a:solidFill>
                  <a:srgbClr val="000000"/>
                </a:solidFill>
                <a:latin typeface="PalatinoLinotype-Roman"/>
              </a:rPr>
              <a:t>. The numbers of predicted CAREs in the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gCBM</a:t>
            </a:r>
            <a:r>
              <a:rPr lang="en-US" altLang="zh-CN" dirty="0">
                <a:solidFill>
                  <a:srgbClr val="000000"/>
                </a:solidFill>
                <a:latin typeface="PalatinoLinotype-Roman"/>
              </a:rPr>
              <a:t> promoter regions. </a:t>
            </a:r>
            <a:endParaRPr lang="zh-CN" altLang="en-US" dirty="0">
              <a:solidFill>
                <a:srgbClr val="000000"/>
              </a:solidFill>
              <a:latin typeface="PalatinoLinotype-Roman"/>
            </a:endParaRPr>
          </a:p>
        </p:txBody>
      </p:sp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621B492A-1A76-5B6F-8A7C-AE2716B8BF2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28478539"/>
              </p:ext>
            </p:extLst>
          </p:nvPr>
        </p:nvGraphicFramePr>
        <p:xfrm>
          <a:off x="1515828" y="485775"/>
          <a:ext cx="8753474" cy="53435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84887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0</TotalTime>
  <Words>48</Words>
  <Application>Microsoft Office PowerPoint</Application>
  <PresentationFormat>宽屏</PresentationFormat>
  <Paragraphs>1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PalatinoLinotype-Roman</vt:lpstr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afei Wang</dc:creator>
  <cp:lastModifiedBy>Yafei Wang</cp:lastModifiedBy>
  <cp:revision>81</cp:revision>
  <cp:lastPrinted>2024-11-12T08:55:06Z</cp:lastPrinted>
  <dcterms:created xsi:type="dcterms:W3CDTF">2024-09-28T14:32:17Z</dcterms:created>
  <dcterms:modified xsi:type="dcterms:W3CDTF">2025-01-03T11:18:36Z</dcterms:modified>
</cp:coreProperties>
</file>